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8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108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98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798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87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832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738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765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1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464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716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8E531-EF92-4076-A089-9CFB04699A1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38BF30-C7EA-4BC4-B634-F0B7ADB6D0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295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l Video 2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730655" y="3509963"/>
            <a:ext cx="6730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presentative MRI Videos at 1 week and 52 weeks post-implant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14153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838200" y="1"/>
            <a:ext cx="10515600" cy="7385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 smtClean="0"/>
              <a:t>1 Week IVC</a:t>
            </a:r>
            <a:endParaRPr lang="en-US" dirty="0"/>
          </a:p>
        </p:txBody>
      </p:sp>
      <p:pic>
        <p:nvPicPr>
          <p:cNvPr id="6" name="low IVC PC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" y="914399"/>
            <a:ext cx="11887200" cy="59436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086126" y="92218"/>
            <a:ext cx="11780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ue: IVC</a:t>
            </a:r>
          </a:p>
          <a:p>
            <a:r>
              <a:rPr lang="en-US" dirty="0" smtClean="0"/>
              <a:t>Red: Aort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75473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838200" y="1"/>
            <a:ext cx="10515600" cy="7385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 smtClean="0"/>
              <a:t>1 Week TEVG</a:t>
            </a:r>
            <a:endParaRPr lang="en-US" dirty="0"/>
          </a:p>
        </p:txBody>
      </p:sp>
      <p:pic>
        <p:nvPicPr>
          <p:cNvPr id="5" name="midTEVG">
            <a:hlinkClick r:id="" action="ppaction://media"/>
            <a:extLst>
              <a:ext uri="{FF2B5EF4-FFF2-40B4-BE49-F238E27FC236}">
                <a16:creationId xmlns:a16="http://schemas.microsoft.com/office/drawing/2014/main" id="{B5008110-0591-A44F-8A5E-545921C3207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" y="914399"/>
            <a:ext cx="11887200" cy="594360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086126" y="92218"/>
            <a:ext cx="12141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ue: TEVG</a:t>
            </a:r>
          </a:p>
          <a:p>
            <a:r>
              <a:rPr lang="en-US" dirty="0" smtClean="0"/>
              <a:t>Red: Aort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12623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838200" y="1"/>
            <a:ext cx="10515600" cy="7385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 smtClean="0"/>
              <a:t>1 Year IVC</a:t>
            </a:r>
            <a:endParaRPr lang="en-US" dirty="0"/>
          </a:p>
        </p:txBody>
      </p:sp>
      <p:pic>
        <p:nvPicPr>
          <p:cNvPr id="5" name="diap">
            <a:hlinkClick r:id="" action="ppaction://media"/>
            <a:extLst>
              <a:ext uri="{FF2B5EF4-FFF2-40B4-BE49-F238E27FC236}">
                <a16:creationId xmlns:a16="http://schemas.microsoft.com/office/drawing/2014/main" id="{EF29209D-F738-43B8-A192-7A7C6288C7A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" y="914400"/>
            <a:ext cx="11887200" cy="59436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086126" y="92218"/>
            <a:ext cx="11780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ue: IVC</a:t>
            </a:r>
          </a:p>
          <a:p>
            <a:r>
              <a:rPr lang="en-US" dirty="0" smtClean="0"/>
              <a:t>Red: Aort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57123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idTEVG">
            <a:hlinkClick r:id="" action="ppaction://media"/>
            <a:extLst>
              <a:ext uri="{FF2B5EF4-FFF2-40B4-BE49-F238E27FC236}">
                <a16:creationId xmlns:a16="http://schemas.microsoft.com/office/drawing/2014/main" id="{D3CC0ECF-D92D-4421-8BE5-381B0A41FB1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" y="914400"/>
            <a:ext cx="11887200" cy="59436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1"/>
            <a:ext cx="10515600" cy="738548"/>
          </a:xfrm>
        </p:spPr>
        <p:txBody>
          <a:bodyPr/>
          <a:lstStyle/>
          <a:p>
            <a:pPr algn="ctr"/>
            <a:r>
              <a:rPr lang="en-US" dirty="0" smtClean="0"/>
              <a:t>1 Year TEVG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9086126" y="92218"/>
            <a:ext cx="12141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ue: TEVG</a:t>
            </a:r>
          </a:p>
          <a:p>
            <a:r>
              <a:rPr lang="en-US" dirty="0" smtClean="0"/>
              <a:t>Red: Aort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27267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99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14</Paragraphs>
  <Slides>5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l Video 2</vt:lpstr>
      <vt:lpstr>PowerPoint Presentation</vt:lpstr>
      <vt:lpstr>PowerPoint Presentation</vt:lpstr>
      <vt:lpstr>PowerPoint Presentation</vt:lpstr>
      <vt:lpstr>1 Year TEVG</vt:lpstr>
    </vt:vector>
  </TitlesOfParts>
  <Company>NCH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RI Imaging</dc:title>
  <dc:creator>Blum, Kevin</dc:creator>
  <cp:lastModifiedBy>Blum, Kevin</cp:lastModifiedBy>
  <cp:revision>3</cp:revision>
  <dcterms:created xsi:type="dcterms:W3CDTF">2020-12-30T14:41:45Z</dcterms:created>
  <dcterms:modified xsi:type="dcterms:W3CDTF">2021-04-01T19:51:12Z</dcterms:modified>
</cp:coreProperties>
</file>